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424" y="-1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886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192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9481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1912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6630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8474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7113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7967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768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3428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356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04DAAB-626B-46F8-9FC4-5322E1A815AA}" type="datetimeFigureOut">
              <a:rPr lang="en-GB" smtClean="0"/>
              <a:t>29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836167-0623-45E4-A473-05774C6A50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9778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03648" y="5661248"/>
            <a:ext cx="67687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Regional plot of </a:t>
            </a:r>
            <a:r>
              <a:rPr lang="en-GB" i="1" dirty="0" smtClean="0">
                <a:latin typeface="Arial" panose="020B0604020202020204" pitchFamily="34" charset="0"/>
                <a:cs typeface="Arial" panose="020B0604020202020204" pitchFamily="34" charset="0"/>
              </a:rPr>
              <a:t>NOX4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gene area</a:t>
            </a:r>
            <a:endParaRPr lang="en-GB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 represents the linkage disequilibrium among SNPs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2" descr="C:\Users\wmeng\Downloads\Desktop\chr11_regionalplo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8384"/>
            <a:ext cx="9144000" cy="5124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228184" y="404664"/>
            <a:ext cx="2232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r</a:t>
            </a:r>
            <a:r>
              <a:rPr lang="en-GB" sz="1100" dirty="0" smtClean="0"/>
              <a:t>s10765219 and  rs11018670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028676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hua Meng</dc:creator>
  <cp:lastModifiedBy>Weihua Meng</cp:lastModifiedBy>
  <cp:revision>8</cp:revision>
  <dcterms:created xsi:type="dcterms:W3CDTF">2015-04-07T13:05:35Z</dcterms:created>
  <dcterms:modified xsi:type="dcterms:W3CDTF">2016-11-29T13:33:27Z</dcterms:modified>
</cp:coreProperties>
</file>